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61" r:id="rId5"/>
    <p:sldId id="25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32" autoAdjust="0"/>
    <p:restoredTop sz="94660"/>
  </p:normalViewPr>
  <p:slideViewPr>
    <p:cSldViewPr snapToGrid="0">
      <p:cViewPr varScale="1">
        <p:scale>
          <a:sx n="62" d="100"/>
          <a:sy n="62" d="100"/>
        </p:scale>
        <p:origin x="253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wmf"/><Relationship Id="rId2" Type="http://schemas.openxmlformats.org/officeDocument/2006/relationships/image" Target="../media/image5.wmf"/><Relationship Id="rId1" Type="http://schemas.openxmlformats.org/officeDocument/2006/relationships/image" Target="../media/image4.wmf"/><Relationship Id="rId4" Type="http://schemas.openxmlformats.org/officeDocument/2006/relationships/image" Target="../media/image7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8712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9787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67709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3661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92750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64930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1929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45092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8020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5313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71682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6C0FB-AD57-46A0-B2F1-66641B087F94}" type="datetimeFigureOut">
              <a:rPr lang="en-IN" smtClean="0"/>
              <a:t>31-08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DC10FE-47DC-450D-8946-B10BDA64E18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7799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wmf"/><Relationship Id="rId11" Type="http://schemas.openxmlformats.org/officeDocument/2006/relationships/image" Target="../media/image7.wmf"/><Relationship Id="rId5" Type="http://schemas.openxmlformats.org/officeDocument/2006/relationships/oleObject" Target="../embeddings/oleObject2.bin"/><Relationship Id="rId10" Type="http://schemas.openxmlformats.org/officeDocument/2006/relationships/oleObject" Target="../embeddings/oleObject4.bin"/><Relationship Id="rId4" Type="http://schemas.openxmlformats.org/officeDocument/2006/relationships/image" Target="../media/image4.wmf"/><Relationship Id="rId9" Type="http://schemas.openxmlformats.org/officeDocument/2006/relationships/image" Target="../media/image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9.wmf"/><Relationship Id="rId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942794E4-18B8-4935-8FC8-A1846B284D2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9253" y="708021"/>
            <a:ext cx="4759493" cy="356904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DC44B256-B496-4606-AE73-1F76327EB925}"/>
              </a:ext>
            </a:extLst>
          </p:cNvPr>
          <p:cNvSpPr/>
          <p:nvPr/>
        </p:nvSpPr>
        <p:spPr>
          <a:xfrm>
            <a:off x="1690687" y="3036266"/>
            <a:ext cx="3143250" cy="115252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="" xmlns:a16="http://schemas.microsoft.com/office/drawing/2014/main" id="{16038B81-2F31-490D-B9F4-D5779DEEA278}"/>
              </a:ext>
            </a:extLst>
          </p:cNvPr>
          <p:cNvCxnSpPr/>
          <p:nvPr/>
        </p:nvCxnSpPr>
        <p:spPr>
          <a:xfrm flipV="1">
            <a:off x="1524000" y="4271233"/>
            <a:ext cx="333375" cy="523875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7FC9D300-F5C8-403F-B41D-53AB796AAC10}"/>
              </a:ext>
            </a:extLst>
          </p:cNvPr>
          <p:cNvSpPr txBox="1"/>
          <p:nvPr/>
        </p:nvSpPr>
        <p:spPr>
          <a:xfrm>
            <a:off x="1181100" y="4795108"/>
            <a:ext cx="10307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Figure 2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8671685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="" xmlns:a16="http://schemas.microsoft.com/office/drawing/2014/main" id="{014736DB-A562-4264-979E-2A7C374EFAE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175" y="2219666"/>
            <a:ext cx="5410200" cy="4056999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="" xmlns:a16="http://schemas.microsoft.com/office/drawing/2014/main" id="{C66EF5A9-1EF8-4651-8078-B71216C19144}"/>
              </a:ext>
            </a:extLst>
          </p:cNvPr>
          <p:cNvSpPr/>
          <p:nvPr/>
        </p:nvSpPr>
        <p:spPr>
          <a:xfrm>
            <a:off x="1569614" y="3074400"/>
            <a:ext cx="3278611" cy="11451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97388AB2-70EC-4B01-992F-5336C38CD40D}"/>
              </a:ext>
            </a:extLst>
          </p:cNvPr>
          <p:cNvSpPr/>
          <p:nvPr/>
        </p:nvSpPr>
        <p:spPr>
          <a:xfrm>
            <a:off x="2421979" y="4329009"/>
            <a:ext cx="1778546" cy="124798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cxnSp>
        <p:nvCxnSpPr>
          <p:cNvPr id="7" name="Straight Arrow Connector 6">
            <a:extLst>
              <a:ext uri="{FF2B5EF4-FFF2-40B4-BE49-F238E27FC236}">
                <a16:creationId xmlns="" xmlns:a16="http://schemas.microsoft.com/office/drawing/2014/main" id="{9E97E512-C240-409B-8288-8EF0D03A3812}"/>
              </a:ext>
            </a:extLst>
          </p:cNvPr>
          <p:cNvCxnSpPr/>
          <p:nvPr/>
        </p:nvCxnSpPr>
        <p:spPr>
          <a:xfrm flipV="1">
            <a:off x="1107774" y="4891296"/>
            <a:ext cx="333375" cy="523875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="" xmlns:a16="http://schemas.microsoft.com/office/drawing/2014/main" id="{94CBD831-5964-4276-8491-4CDA407CFF6B}"/>
              </a:ext>
            </a:extLst>
          </p:cNvPr>
          <p:cNvCxnSpPr>
            <a:cxnSpLocks/>
          </p:cNvCxnSpPr>
          <p:nvPr/>
        </p:nvCxnSpPr>
        <p:spPr>
          <a:xfrm flipV="1">
            <a:off x="1990722" y="5686426"/>
            <a:ext cx="342901" cy="899904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1F14CD07-F910-4A8A-913F-F70ADEB48A3B}"/>
              </a:ext>
            </a:extLst>
          </p:cNvPr>
          <p:cNvSpPr txBox="1"/>
          <p:nvPr/>
        </p:nvSpPr>
        <p:spPr>
          <a:xfrm>
            <a:off x="893339" y="5387734"/>
            <a:ext cx="997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>
                <a:solidFill>
                  <a:schemeClr val="bg1"/>
                </a:solidFill>
              </a:rPr>
              <a:t>Figure 5</a:t>
            </a:r>
            <a:endParaRPr lang="en-IN" dirty="0">
              <a:solidFill>
                <a:schemeClr val="bg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456069E6-11B4-4D27-A2B7-40CF407FDBFD}"/>
              </a:ext>
            </a:extLst>
          </p:cNvPr>
          <p:cNvSpPr txBox="1"/>
          <p:nvPr/>
        </p:nvSpPr>
        <p:spPr>
          <a:xfrm>
            <a:off x="1657348" y="6586330"/>
            <a:ext cx="9993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Figure 6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0312839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1F01D726-C265-4B6B-A204-3ACFB6F4182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714" y="2567558"/>
            <a:ext cx="5330571" cy="399728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="" xmlns:a16="http://schemas.microsoft.com/office/drawing/2014/main" id="{681CFFD6-ECCC-4416-9CDF-651A30D2897C}"/>
              </a:ext>
            </a:extLst>
          </p:cNvPr>
          <p:cNvSpPr/>
          <p:nvPr/>
        </p:nvSpPr>
        <p:spPr>
          <a:xfrm>
            <a:off x="1604961" y="3528965"/>
            <a:ext cx="2528889" cy="11715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sp>
        <p:nvSpPr>
          <p:cNvPr id="7" name="Rectangle 6">
            <a:extLst>
              <a:ext uri="{FF2B5EF4-FFF2-40B4-BE49-F238E27FC236}">
                <a16:creationId xmlns="" xmlns:a16="http://schemas.microsoft.com/office/drawing/2014/main" id="{DDE07B5C-0D51-4510-9B20-2DC45001B116}"/>
              </a:ext>
            </a:extLst>
          </p:cNvPr>
          <p:cNvSpPr/>
          <p:nvPr/>
        </p:nvSpPr>
        <p:spPr>
          <a:xfrm>
            <a:off x="1604961" y="4829175"/>
            <a:ext cx="2033590" cy="124798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="" xmlns:a16="http://schemas.microsoft.com/office/drawing/2014/main" id="{E0F8DEEA-4BD4-4186-B177-41BFC5A6692D}"/>
              </a:ext>
            </a:extLst>
          </p:cNvPr>
          <p:cNvCxnSpPr>
            <a:cxnSpLocks/>
          </p:cNvCxnSpPr>
          <p:nvPr/>
        </p:nvCxnSpPr>
        <p:spPr>
          <a:xfrm flipH="1" flipV="1">
            <a:off x="4171855" y="3807076"/>
            <a:ext cx="365188" cy="307676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="" xmlns:a16="http://schemas.microsoft.com/office/drawing/2014/main" id="{C49727E3-732A-4DD7-9DC1-BF6410115A05}"/>
              </a:ext>
            </a:extLst>
          </p:cNvPr>
          <p:cNvCxnSpPr>
            <a:cxnSpLocks/>
          </p:cNvCxnSpPr>
          <p:nvPr/>
        </p:nvCxnSpPr>
        <p:spPr>
          <a:xfrm flipH="1" flipV="1">
            <a:off x="3711513" y="5244548"/>
            <a:ext cx="642936" cy="190501"/>
          </a:xfrm>
          <a:prstGeom prst="straightConnector1">
            <a:avLst/>
          </a:prstGeom>
          <a:ln w="571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="" xmlns:a16="http://schemas.microsoft.com/office/drawing/2014/main" id="{FA545B1A-97D2-44BC-B68E-5B1763317E25}"/>
              </a:ext>
            </a:extLst>
          </p:cNvPr>
          <p:cNvSpPr txBox="1"/>
          <p:nvPr/>
        </p:nvSpPr>
        <p:spPr>
          <a:xfrm>
            <a:off x="4133850" y="4114752"/>
            <a:ext cx="16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>
                <a:solidFill>
                  <a:schemeClr val="bg1"/>
                </a:solidFill>
              </a:rPr>
              <a:t>Figure S4 (b)</a:t>
            </a:r>
            <a:endParaRPr lang="en-IN" dirty="0">
              <a:solidFill>
                <a:schemeClr val="bg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4EE6B21B-5797-4B93-8A01-DE3A7284F514}"/>
              </a:ext>
            </a:extLst>
          </p:cNvPr>
          <p:cNvSpPr txBox="1"/>
          <p:nvPr/>
        </p:nvSpPr>
        <p:spPr>
          <a:xfrm>
            <a:off x="4427411" y="5234292"/>
            <a:ext cx="1058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>
                <a:solidFill>
                  <a:schemeClr val="bg1"/>
                </a:solidFill>
              </a:rPr>
              <a:t>Figure 7 </a:t>
            </a:r>
            <a:endParaRPr lang="en-IN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1908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="" xmlns:a16="http://schemas.microsoft.com/office/drawing/2014/main" id="{E53C25DC-A528-471D-8042-130018A6A8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8993347"/>
              </p:ext>
            </p:extLst>
          </p:nvPr>
        </p:nvGraphicFramePr>
        <p:xfrm>
          <a:off x="3606798" y="5804503"/>
          <a:ext cx="2898773" cy="1857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r:id="rId3" imgW="4910040" imgH="2862000" progId="">
                  <p:embed/>
                </p:oleObj>
              </mc:Choice>
              <mc:Fallback>
                <p:oleObj r:id="rId3" imgW="4910040" imgH="2862000" progId="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06798" y="5804503"/>
                        <a:ext cx="2898773" cy="1857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="" xmlns:a16="http://schemas.microsoft.com/office/drawing/2014/main" id="{91A803B6-E1FF-41AF-AFAD-DFD07E08FB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7586924"/>
              </p:ext>
            </p:extLst>
          </p:nvPr>
        </p:nvGraphicFramePr>
        <p:xfrm>
          <a:off x="3606798" y="3095466"/>
          <a:ext cx="2898773" cy="1857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r:id="rId5" imgW="4169520" imgH="2916720" progId="">
                  <p:embed/>
                </p:oleObj>
              </mc:Choice>
              <mc:Fallback>
                <p:oleObj r:id="rId5" imgW="4169520" imgH="2916720" progId="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06798" y="3095466"/>
                        <a:ext cx="2898773" cy="1857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="" xmlns:a16="http://schemas.microsoft.com/office/drawing/2014/main" id="{96FE10A9-3323-47C4-81E1-7C0FB7AD47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9118164"/>
              </p:ext>
            </p:extLst>
          </p:nvPr>
        </p:nvGraphicFramePr>
        <p:xfrm>
          <a:off x="390026" y="511956"/>
          <a:ext cx="2898773" cy="1857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r:id="rId7" imgW="4690800" imgH="3328200" progId="">
                  <p:embed/>
                </p:oleObj>
              </mc:Choice>
              <mc:Fallback>
                <p:oleObj r:id="rId7" imgW="4690800" imgH="3328200" progId="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0026" y="511956"/>
                        <a:ext cx="2898773" cy="1857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99250002-6999-4476-94D8-CCD121F7D1E5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025" y="5808097"/>
            <a:ext cx="2898773" cy="1857534"/>
          </a:xfrm>
          <a:prstGeom prst="rect">
            <a:avLst/>
          </a:prstGeom>
        </p:spPr>
      </p:pic>
      <p:graphicFrame>
        <p:nvGraphicFramePr>
          <p:cNvPr id="6" name="Object 5">
            <a:extLst>
              <a:ext uri="{FF2B5EF4-FFF2-40B4-BE49-F238E27FC236}">
                <a16:creationId xmlns="" xmlns:a16="http://schemas.microsoft.com/office/drawing/2014/main" id="{FF70632F-1184-45F1-BF1D-C0A45612F9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2213934"/>
              </p:ext>
            </p:extLst>
          </p:nvPr>
        </p:nvGraphicFramePr>
        <p:xfrm>
          <a:off x="390025" y="3095466"/>
          <a:ext cx="2898773" cy="1857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r:id="rId10" imgW="5019840" imgH="2560320" progId="">
                  <p:embed/>
                </p:oleObj>
              </mc:Choice>
              <mc:Fallback>
                <p:oleObj r:id="rId10" imgW="5019840" imgH="2560320" progId="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90025" y="3095466"/>
                        <a:ext cx="2898773" cy="1857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="" xmlns:a16="http://schemas.microsoft.com/office/drawing/2014/main" id="{4E532505-2FEC-4F8C-8531-9DFD908598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3558632"/>
              </p:ext>
            </p:extLst>
          </p:nvPr>
        </p:nvGraphicFramePr>
        <p:xfrm>
          <a:off x="3606798" y="511796"/>
          <a:ext cx="2916877" cy="1857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r:id="rId12" imgW="4690800" imgH="3328200" progId="">
                  <p:embed/>
                </p:oleObj>
              </mc:Choice>
              <mc:Fallback>
                <p:oleObj r:id="rId12" imgW="4690800" imgH="3328200" progId="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606798" y="511796"/>
                        <a:ext cx="2916877" cy="1857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63D15528-0E68-4898-A744-4E4565B872B5}"/>
              </a:ext>
            </a:extLst>
          </p:cNvPr>
          <p:cNvSpPr txBox="1"/>
          <p:nvPr/>
        </p:nvSpPr>
        <p:spPr>
          <a:xfrm>
            <a:off x="1159791" y="2433473"/>
            <a:ext cx="62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(b)</a:t>
            </a:r>
            <a:endParaRPr lang="en-IN" dirty="0"/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8F2A1A10-4077-4020-A358-14EB0274C111}"/>
              </a:ext>
            </a:extLst>
          </p:cNvPr>
          <p:cNvSpPr txBox="1"/>
          <p:nvPr/>
        </p:nvSpPr>
        <p:spPr>
          <a:xfrm>
            <a:off x="2378249" y="8709229"/>
            <a:ext cx="1172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Figure S1 </a:t>
            </a:r>
            <a:endParaRPr lang="en-IN" dirty="0"/>
          </a:p>
        </p:txBody>
      </p:sp>
      <p:sp>
        <p:nvSpPr>
          <p:cNvPr id="12" name="TextBox 11">
            <a:extLst>
              <a:ext uri="{FF2B5EF4-FFF2-40B4-BE49-F238E27FC236}">
                <a16:creationId xmlns="" xmlns:a16="http://schemas.microsoft.com/office/drawing/2014/main" id="{63D15528-0E68-4898-A744-4E4565B872B5}"/>
              </a:ext>
            </a:extLst>
          </p:cNvPr>
          <p:cNvSpPr txBox="1"/>
          <p:nvPr/>
        </p:nvSpPr>
        <p:spPr>
          <a:xfrm>
            <a:off x="4441315" y="2425749"/>
            <a:ext cx="62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(c)</a:t>
            </a:r>
            <a:endParaRPr lang="en-IN" dirty="0"/>
          </a:p>
        </p:txBody>
      </p: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63D15528-0E68-4898-A744-4E4565B872B5}"/>
              </a:ext>
            </a:extLst>
          </p:cNvPr>
          <p:cNvSpPr txBox="1"/>
          <p:nvPr/>
        </p:nvSpPr>
        <p:spPr>
          <a:xfrm>
            <a:off x="1159790" y="5011216"/>
            <a:ext cx="62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(d)</a:t>
            </a:r>
            <a:endParaRPr lang="en-IN" dirty="0"/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63D15528-0E68-4898-A744-4E4565B872B5}"/>
              </a:ext>
            </a:extLst>
          </p:cNvPr>
          <p:cNvSpPr txBox="1"/>
          <p:nvPr/>
        </p:nvSpPr>
        <p:spPr>
          <a:xfrm>
            <a:off x="4441315" y="5136306"/>
            <a:ext cx="62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(e)</a:t>
            </a:r>
            <a:endParaRPr lang="en-IN" dirty="0"/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63D15528-0E68-4898-A744-4E4565B872B5}"/>
              </a:ext>
            </a:extLst>
          </p:cNvPr>
          <p:cNvSpPr txBox="1"/>
          <p:nvPr/>
        </p:nvSpPr>
        <p:spPr>
          <a:xfrm>
            <a:off x="1159789" y="7907359"/>
            <a:ext cx="62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(f)</a:t>
            </a:r>
            <a:endParaRPr lang="en-IN" dirty="0"/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63D15528-0E68-4898-A744-4E4565B872B5}"/>
              </a:ext>
            </a:extLst>
          </p:cNvPr>
          <p:cNvSpPr txBox="1"/>
          <p:nvPr/>
        </p:nvSpPr>
        <p:spPr>
          <a:xfrm>
            <a:off x="4441315" y="8023429"/>
            <a:ext cx="623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(g)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5278368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55238DE6-58F0-4576-8A19-FA6D82A06AA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867" b="26255"/>
          <a:stretch/>
        </p:blipFill>
        <p:spPr>
          <a:xfrm>
            <a:off x="591936" y="2770414"/>
            <a:ext cx="5850196" cy="211727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F863892A-6044-40E8-B490-1ECE3A012646}"/>
              </a:ext>
            </a:extLst>
          </p:cNvPr>
          <p:cNvSpPr txBox="1"/>
          <p:nvPr/>
        </p:nvSpPr>
        <p:spPr>
          <a:xfrm>
            <a:off x="2457376" y="5088112"/>
            <a:ext cx="1609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Figure S2 </a:t>
            </a:r>
            <a:r>
              <a:rPr lang="en-IN" dirty="0"/>
              <a:t>(a)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="" xmlns:a16="http://schemas.microsoft.com/office/drawing/2014/main" id="{A663E8C0-F8EA-4998-8018-BE5A71D30C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4884702"/>
              </p:ext>
            </p:extLst>
          </p:nvPr>
        </p:nvGraphicFramePr>
        <p:xfrm>
          <a:off x="2025425" y="6600155"/>
          <a:ext cx="2546575" cy="17574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r:id="rId4" imgW="1511640" imgH="1042200" progId="">
                  <p:embed/>
                </p:oleObj>
              </mc:Choice>
              <mc:Fallback>
                <p:oleObj r:id="rId4" imgW="1511640" imgH="1042200" progId="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="" xmlns:a16="http://schemas.microsoft.com/office/drawing/2014/main" id="{569E50D1-5916-48E5-B9F0-708192E127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25425" y="6600155"/>
                        <a:ext cx="2546575" cy="17574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F863892A-6044-40E8-B490-1ECE3A012646}"/>
              </a:ext>
            </a:extLst>
          </p:cNvPr>
          <p:cNvSpPr txBox="1"/>
          <p:nvPr/>
        </p:nvSpPr>
        <p:spPr>
          <a:xfrm>
            <a:off x="3914131" y="8558038"/>
            <a:ext cx="1609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>
                <a:solidFill>
                  <a:schemeClr val="bg1"/>
                </a:solidFill>
              </a:rPr>
              <a:t>Figure S2 </a:t>
            </a:r>
            <a:r>
              <a:rPr lang="en-IN" dirty="0">
                <a:solidFill>
                  <a:schemeClr val="bg1"/>
                </a:solidFill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F863892A-6044-40E8-B490-1ECE3A012646}"/>
              </a:ext>
            </a:extLst>
          </p:cNvPr>
          <p:cNvSpPr txBox="1"/>
          <p:nvPr/>
        </p:nvSpPr>
        <p:spPr>
          <a:xfrm>
            <a:off x="2457376" y="8373372"/>
            <a:ext cx="1609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 smtClean="0"/>
              <a:t>Figure S2 (b)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11052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</TotalTime>
  <Words>48</Words>
  <Application>Microsoft Office PowerPoint</Application>
  <PresentationFormat>A4 Paper (210x297 mm)</PresentationFormat>
  <Paragraphs>15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Microsoft account</cp:lastModifiedBy>
  <cp:revision>17</cp:revision>
  <dcterms:created xsi:type="dcterms:W3CDTF">2024-08-31T11:55:43Z</dcterms:created>
  <dcterms:modified xsi:type="dcterms:W3CDTF">2024-08-31T17:49:18Z</dcterms:modified>
</cp:coreProperties>
</file>